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45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michaelding:Downloads:western%20quantification%20FAS,%20AMPK,%20atrogin%20GWT%20GKO%20old%20mice%20G%20and%20Control%208-21-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aelding:Documents:Michael%20PCR%20Old%20Treatmen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ichaelding:Documents:Michael%20PCR%20Old%20Treatmen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Worksheet%20in%20Aging%20Figures%2020161011-2%20(2)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C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lt1"/>
            </a:solidFill>
            <a:ln w="3175" cap="flat" cmpd="sng" algn="ctr">
              <a:solidFill>
                <a:schemeClr val="dk1"/>
              </a:solidFill>
              <a:prstDash val="solid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AE$28:$AF$28</c:f>
                <c:numCache>
                  <c:formatCode>General</c:formatCode>
                  <c:ptCount val="2"/>
                  <c:pt idx="0">
                    <c:v>6.7327390970101195E-2</c:v>
                  </c:pt>
                  <c:pt idx="1">
                    <c:v>5.65345909509381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B$28:$AB$29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Sheet1!$AC$28:$AC$29</c:f>
              <c:numCache>
                <c:formatCode>General</c:formatCode>
                <c:ptCount val="2"/>
                <c:pt idx="0">
                  <c:v>0.22798312867501899</c:v>
                </c:pt>
                <c:pt idx="1">
                  <c:v>0.35935549171484998</c:v>
                </c:pt>
              </c:numCache>
            </c:numRef>
          </c:val>
        </c:ser>
        <c:ser>
          <c:idx val="1"/>
          <c:order val="1"/>
          <c:tx>
            <c:strRef>
              <c:f>Sheet1!$AD$5</c:f>
              <c:strCache>
                <c:ptCount val="1"/>
                <c:pt idx="0">
                  <c:v>Ghrelin</c:v>
                </c:pt>
              </c:strCache>
            </c:strRef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AE$29:$AF$29</c:f>
                <c:numCache>
                  <c:formatCode>General</c:formatCode>
                  <c:ptCount val="2"/>
                  <c:pt idx="0">
                    <c:v>0.14907511788307401</c:v>
                  </c:pt>
                  <c:pt idx="1">
                    <c:v>8.009467517522770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B$28:$AB$29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Sheet1!$AD$28:$AD$29</c:f>
              <c:numCache>
                <c:formatCode>General</c:formatCode>
                <c:ptCount val="2"/>
                <c:pt idx="0">
                  <c:v>0.232327098155549</c:v>
                </c:pt>
                <c:pt idx="1">
                  <c:v>0.39230698817867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202304"/>
        <c:axId val="47203840"/>
      </c:barChart>
      <c:catAx>
        <c:axId val="472023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7203840"/>
        <c:crosses val="autoZero"/>
        <c:auto val="1"/>
        <c:lblAlgn val="ctr"/>
        <c:lblOffset val="100"/>
        <c:noMultiLvlLbl val="0"/>
      </c:catAx>
      <c:valAx>
        <c:axId val="47203840"/>
        <c:scaling>
          <c:orientation val="minMax"/>
          <c:max val="0.4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AS</a:t>
                </a:r>
                <a:r>
                  <a:rPr lang="en-US" baseline="0"/>
                  <a:t> </a:t>
                </a:r>
                <a:r>
                  <a:rPr lang="en-US"/>
                  <a:t>/ GAPDH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7202304"/>
        <c:crosses val="autoZero"/>
        <c:crossBetween val="between"/>
        <c:majorUnit val="0.1"/>
      </c:valAx>
    </c:plotArea>
    <c:legend>
      <c:legendPos val="r"/>
      <c:layout>
        <c:manualLayout>
          <c:xMode val="edge"/>
          <c:yMode val="edge"/>
          <c:x val="0.73437215084956498"/>
          <c:y val="4.6189424492670099E-2"/>
          <c:w val="0.23864829396325499"/>
          <c:h val="0.1969072615923009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CR Data, Graphs'!$K$2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lt1"/>
            </a:solidFill>
            <a:ln w="3175" cap="flat" cmpd="sng" algn="ctr">
              <a:solidFill>
                <a:schemeClr val="dk1"/>
              </a:solidFill>
              <a:prstDash val="solid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CR Data, Graphs'!$O$26:$O$27</c:f>
                <c:numCache>
                  <c:formatCode>General</c:formatCode>
                  <c:ptCount val="2"/>
                  <c:pt idx="0">
                    <c:v>0.178474199196164</c:v>
                  </c:pt>
                  <c:pt idx="1">
                    <c:v>0.775581814255648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CR Data, Graphs'!$J$26:$J$2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PCR Data, Graphs'!$K$26:$K$27</c:f>
              <c:numCache>
                <c:formatCode>General</c:formatCode>
                <c:ptCount val="2"/>
                <c:pt idx="0">
                  <c:v>1</c:v>
                </c:pt>
                <c:pt idx="1">
                  <c:v>1.6228550630752621</c:v>
                </c:pt>
              </c:numCache>
            </c:numRef>
          </c:val>
        </c:ser>
        <c:ser>
          <c:idx val="1"/>
          <c:order val="1"/>
          <c:tx>
            <c:strRef>
              <c:f>'PCR Data, Graphs'!$L$25</c:f>
              <c:strCache>
                <c:ptCount val="1"/>
                <c:pt idx="0">
                  <c:v>Ghrel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PCR Data, Graphs'!$P$26:$P$27</c:f>
                <c:numCache>
                  <c:formatCode>General</c:formatCode>
                  <c:ptCount val="2"/>
                  <c:pt idx="0">
                    <c:v>1.221103637376491</c:v>
                  </c:pt>
                  <c:pt idx="1">
                    <c:v>0.556726965863011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CR Data, Graphs'!$J$26:$J$2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PCR Data, Graphs'!$L$26:$L$27</c:f>
              <c:numCache>
                <c:formatCode>General</c:formatCode>
                <c:ptCount val="2"/>
                <c:pt idx="0">
                  <c:v>2.560006033360545</c:v>
                </c:pt>
                <c:pt idx="1">
                  <c:v>1.2036238022794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259008"/>
        <c:axId val="47264896"/>
      </c:barChart>
      <c:catAx>
        <c:axId val="47259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7264896"/>
        <c:crosses val="autoZero"/>
        <c:auto val="1"/>
        <c:lblAlgn val="ctr"/>
        <c:lblOffset val="100"/>
        <c:noMultiLvlLbl val="0"/>
      </c:catAx>
      <c:valAx>
        <c:axId val="472648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DK-4 / </a:t>
                </a:r>
                <a:r>
                  <a:rPr lang="en-US" dirty="0" smtClean="0"/>
                  <a:t>GAPDH (fold increase)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72590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460126859142596"/>
          <c:y val="5.1764291658664599E-2"/>
          <c:w val="0.16317650918635199"/>
          <c:h val="0.17289418091031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CR Data, Graphs'!$C$2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lt1"/>
            </a:solidFill>
            <a:ln w="3175" cap="flat" cmpd="sng" algn="ctr">
              <a:solidFill>
                <a:schemeClr val="dk1"/>
              </a:solidFill>
              <a:prstDash val="solid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CR Data, Graphs'!$G$26:$G$27</c:f>
                <c:numCache>
                  <c:formatCode>General</c:formatCode>
                  <c:ptCount val="2"/>
                  <c:pt idx="0">
                    <c:v>0.27919701446859801</c:v>
                  </c:pt>
                  <c:pt idx="1">
                    <c:v>0.67048821406155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CR Data, Graphs'!$B$26:$B$2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PCR Data, Graphs'!$C$26:$C$27</c:f>
              <c:numCache>
                <c:formatCode>General</c:formatCode>
                <c:ptCount val="2"/>
                <c:pt idx="0">
                  <c:v>1</c:v>
                </c:pt>
                <c:pt idx="1">
                  <c:v>1.8452911081027361</c:v>
                </c:pt>
              </c:numCache>
            </c:numRef>
          </c:val>
        </c:ser>
        <c:ser>
          <c:idx val="1"/>
          <c:order val="1"/>
          <c:tx>
            <c:strRef>
              <c:f>'PCR Data, Graphs'!$D$25</c:f>
              <c:strCache>
                <c:ptCount val="1"/>
                <c:pt idx="0">
                  <c:v>Ghrel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PCR Data, Graphs'!$H$26:$H$27</c:f>
                <c:numCache>
                  <c:formatCode>General</c:formatCode>
                  <c:ptCount val="2"/>
                  <c:pt idx="0">
                    <c:v>1.5537077869832721</c:v>
                  </c:pt>
                  <c:pt idx="1">
                    <c:v>0.254292197351927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CR Data, Graphs'!$B$26:$B$2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PCR Data, Graphs'!$D$26:$D$27</c:f>
              <c:numCache>
                <c:formatCode>General</c:formatCode>
                <c:ptCount val="2"/>
                <c:pt idx="0">
                  <c:v>2.0443293900071589</c:v>
                </c:pt>
                <c:pt idx="1">
                  <c:v>0.536823303752797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378432"/>
        <c:axId val="47379968"/>
      </c:barChart>
      <c:catAx>
        <c:axId val="473784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7379968"/>
        <c:crosses val="autoZero"/>
        <c:auto val="1"/>
        <c:lblAlgn val="ctr"/>
        <c:lblOffset val="100"/>
        <c:noMultiLvlLbl val="0"/>
      </c:catAx>
      <c:valAx>
        <c:axId val="47379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GF-1 / GAPDH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737843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246845341144281"/>
          <c:y val="4.7951557488547902E-2"/>
          <c:w val="0.65375680027481564"/>
          <c:h val="0.84081027403424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Worksheet in Aging Figures 20161011-2 (2)]Sheet1'!$AK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lt1"/>
            </a:solidFill>
            <a:ln w="3175" cap="flat" cmpd="sng" algn="ctr">
              <a:solidFill>
                <a:schemeClr val="dk1"/>
              </a:solidFill>
              <a:prstDash val="solid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Worksheet in Aging Figures 20161011-2 (2)]Sheet1'!$AM$6:$AN$6</c:f>
                <c:numCache>
                  <c:formatCode>General</c:formatCode>
                  <c:ptCount val="2"/>
                  <c:pt idx="0">
                    <c:v>7.7057343806150227</c:v>
                  </c:pt>
                  <c:pt idx="1">
                    <c:v>2.92307419743463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Worksheet in Aging Figures 20161011-2 (2)]Sheet1'!$AB$6:$AB$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[Worksheet in Aging Figures 20161011-2 (2)]Sheet1'!$AK$6:$AK$7</c:f>
              <c:numCache>
                <c:formatCode>General</c:formatCode>
                <c:ptCount val="2"/>
                <c:pt idx="0">
                  <c:v>20.108835155808819</c:v>
                </c:pt>
                <c:pt idx="1">
                  <c:v>17.601731601731601</c:v>
                </c:pt>
              </c:numCache>
            </c:numRef>
          </c:val>
        </c:ser>
        <c:ser>
          <c:idx val="1"/>
          <c:order val="1"/>
          <c:tx>
            <c:strRef>
              <c:f>'[Worksheet in Aging Figures 20161011-2 (2)]Sheet1'!$AL$5</c:f>
              <c:strCache>
                <c:ptCount val="1"/>
                <c:pt idx="0">
                  <c:v>Ghrelin</c:v>
                </c:pt>
              </c:strCache>
            </c:strRef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Worksheet in Aging Figures 20161011-2 (2)]Sheet1'!$AM$7:$AN$7</c:f>
                <c:numCache>
                  <c:formatCode>General</c:formatCode>
                  <c:ptCount val="2"/>
                  <c:pt idx="0">
                    <c:v>2.1255411255411358</c:v>
                  </c:pt>
                  <c:pt idx="1">
                    <c:v>2.83023735810113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Worksheet in Aging Figures 20161011-2 (2)]Sheet1'!$AB$6:$AB$7</c:f>
              <c:strCache>
                <c:ptCount val="2"/>
                <c:pt idx="0">
                  <c:v>GWT</c:v>
                </c:pt>
                <c:pt idx="1">
                  <c:v>GKO</c:v>
                </c:pt>
              </c:strCache>
            </c:strRef>
          </c:cat>
          <c:val>
            <c:numRef>
              <c:f>'[Worksheet in Aging Figures 20161011-2 (2)]Sheet1'!$AL$6:$AL$7</c:f>
              <c:numCache>
                <c:formatCode>General</c:formatCode>
                <c:ptCount val="2"/>
                <c:pt idx="0">
                  <c:v>14.309935511303237</c:v>
                </c:pt>
                <c:pt idx="1">
                  <c:v>18.2223942208462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410560"/>
        <c:axId val="50156672"/>
      </c:barChart>
      <c:catAx>
        <c:axId val="47410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50156672"/>
        <c:crosses val="autoZero"/>
        <c:auto val="1"/>
        <c:lblAlgn val="ctr"/>
        <c:lblOffset val="100"/>
        <c:noMultiLvlLbl val="0"/>
      </c:catAx>
      <c:valAx>
        <c:axId val="50156672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aseline="0"/>
                </a:pPr>
                <a:r>
                  <a:rPr lang="en-US" sz="1200" baseline="0"/>
                  <a:t>Atrogin / Tubul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74105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983136174087031"/>
          <c:y val="8.7579104695246393E-2"/>
          <c:w val="0.2959892203344498"/>
          <c:h val="0.19690726159230099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851</cdr:x>
      <cdr:y>0</cdr:y>
    </cdr:from>
    <cdr:to>
      <cdr:x>0.0994</cdr:x>
      <cdr:y>0.11822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80377" y="0"/>
          <a:ext cx="351378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rPr>
            <a:t>C</a:t>
          </a:r>
          <a:endParaRPr lang="en-US" dirty="0">
            <a:solidFill>
              <a:prstClr val="black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7B0DAF-F2B6-4D1E-A564-7223322A3314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51B967-59BE-4A37-9C73-2EED0DECA4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86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1E3B2F-714E-4933-966C-A725D69276D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1432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smtClean="0"/>
          </a:p>
          <a:p>
            <a:r>
              <a:rPr lang="en-US" baseline="0" smtClean="0"/>
              <a:t>Missing IGF-1 serum</a:t>
            </a:r>
          </a:p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1E3B2F-714E-4933-966C-A725D69276DA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6878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772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277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595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25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659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517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779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418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346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279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6D926-A9A0-4486-B5FE-7FCC96EACC2C}" type="datetimeFigureOut">
              <a:rPr lang="en-US" smtClean="0"/>
              <a:t>2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86C08-BD70-4865-8CCF-8DDC907529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603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microsoft.com/office/2007/relationships/hdphoto" Target="../media/hdphoto3.wdp"/><Relationship Id="rId3" Type="http://schemas.openxmlformats.org/officeDocument/2006/relationships/notesSlide" Target="../notesSlides/notesSlide1.xml"/><Relationship Id="rId7" Type="http://schemas.microsoft.com/office/2007/relationships/hdphoto" Target="../media/hdphoto1.wdp"/><Relationship Id="rId12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11" Type="http://schemas.openxmlformats.org/officeDocument/2006/relationships/chart" Target="../charts/chart2.xml"/><Relationship Id="rId5" Type="http://schemas.openxmlformats.org/officeDocument/2006/relationships/image" Target="../media/image1.wmf"/><Relationship Id="rId10" Type="http://schemas.openxmlformats.org/officeDocument/2006/relationships/chart" Target="../charts/chart1.xml"/><Relationship Id="rId4" Type="http://schemas.openxmlformats.org/officeDocument/2006/relationships/oleObject" Target="../embeddings/oleObject1.bin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13" Type="http://schemas.openxmlformats.org/officeDocument/2006/relationships/image" Target="../media/image9.png"/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12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11" Type="http://schemas.openxmlformats.org/officeDocument/2006/relationships/chart" Target="../charts/chart3.xml"/><Relationship Id="rId5" Type="http://schemas.openxmlformats.org/officeDocument/2006/relationships/image" Target="../media/image6.png"/><Relationship Id="rId10" Type="http://schemas.microsoft.com/office/2007/relationships/hdphoto" Target="../media/hdphoto7.wdp"/><Relationship Id="rId4" Type="http://schemas.microsoft.com/office/2007/relationships/hdphoto" Target="../media/hdphoto4.wdp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9743789"/>
              </p:ext>
            </p:extLst>
          </p:nvPr>
        </p:nvGraphicFramePr>
        <p:xfrm>
          <a:off x="504825" y="228600"/>
          <a:ext cx="3832225" cy="2887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SPW 11.0 Graph" r:id="rId4" imgW="5673600" imgH="4157640" progId="SigmaPlotGraphicObject.10">
                  <p:embed/>
                </p:oleObj>
              </mc:Choice>
              <mc:Fallback>
                <p:oleObj name="SPW 11.0 Graph" r:id="rId4" imgW="5673600" imgH="4157640" progId="SigmaPlotGraphicObject.1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4825" y="228600"/>
                        <a:ext cx="3832225" cy="28876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800600" y="1524000"/>
            <a:ext cx="4068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FA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648200" y="1219200"/>
            <a:ext cx="692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p-AMPK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48200" y="1905000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GAPD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848600" y="457200"/>
            <a:ext cx="592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GK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791200" y="838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C</a:t>
            </a:r>
            <a:endParaRPr lang="en-US" dirty="0">
              <a:solidFill>
                <a:prstClr val="black"/>
              </a:solidFill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5638800" y="838200"/>
            <a:ext cx="571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629400" y="838200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G</a:t>
            </a:r>
            <a:endParaRPr lang="en-US" dirty="0">
              <a:solidFill>
                <a:prstClr val="black"/>
              </a:solidFill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6477000" y="838200"/>
            <a:ext cx="522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7391400" y="838200"/>
            <a:ext cx="5715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8305800" y="838200"/>
            <a:ext cx="522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019800" y="457200"/>
            <a:ext cx="646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GWT</a:t>
            </a:r>
          </a:p>
        </p:txBody>
      </p:sp>
      <p:sp>
        <p:nvSpPr>
          <p:cNvPr id="18" name="Rectangle 17"/>
          <p:cNvSpPr/>
          <p:nvPr/>
        </p:nvSpPr>
        <p:spPr>
          <a:xfrm>
            <a:off x="4825332" y="15618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543800" y="838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C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382000" y="838200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G</a:t>
            </a:r>
            <a:endParaRPr lang="en-US" dirty="0">
              <a:solidFill>
                <a:prstClr val="black"/>
              </a:solidFill>
            </a:endParaRPr>
          </a:p>
        </p:txBody>
      </p:sp>
      <p:pic>
        <p:nvPicPr>
          <p:cNvPr id="39" name="Picture 3" descr="E:\Lab 5-7-15\Western Aging 9-2015\10-7-15 photoshop images\Fas b.jpg"/>
          <p:cNvPicPr>
            <a:picLocks noChangeAspect="1" noChangeArrowheads="1"/>
          </p:cNvPicPr>
          <p:nvPr/>
        </p:nvPicPr>
        <p:blipFill>
          <a:blip r:embed="rId6" cstate="print">
            <a:alphaModFix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83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5410200" y="1600200"/>
            <a:ext cx="3657601" cy="2120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0" name="Picture 4" descr="E:\Lab 5-7-15\Western Aging 9-2015\10-7-15 photoshop images\Fas GAPDH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3000"/>
                    </a14:imgEffect>
                  </a14:imgLayer>
                </a14:imgProps>
              </a:ext>
            </a:extLst>
          </a:blip>
          <a:srcRect r="1869" b="-18063"/>
          <a:stretch>
            <a:fillRect/>
          </a:stretch>
        </p:blipFill>
        <p:spPr bwMode="auto">
          <a:xfrm>
            <a:off x="5410200" y="1978690"/>
            <a:ext cx="3657600" cy="2060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graphicFrame>
        <p:nvGraphicFramePr>
          <p:cNvPr id="43" name="Chart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0849378"/>
              </p:ext>
            </p:extLst>
          </p:nvPr>
        </p:nvGraphicFramePr>
        <p:xfrm>
          <a:off x="228600" y="3200400"/>
          <a:ext cx="4343400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1143206"/>
              </p:ext>
            </p:extLst>
          </p:nvPr>
        </p:nvGraphicFramePr>
        <p:xfrm>
          <a:off x="4572000" y="3200400"/>
          <a:ext cx="4267200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5" name="Title 9"/>
          <p:cNvSpPr txBox="1">
            <a:spLocks/>
          </p:cNvSpPr>
          <p:nvPr/>
        </p:nvSpPr>
        <p:spPr>
          <a:xfrm>
            <a:off x="0" y="0"/>
            <a:ext cx="3200400" cy="502324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 smtClean="0"/>
              <a:t>Supplemental figure </a:t>
            </a:r>
            <a:r>
              <a:rPr lang="en-US" sz="2400" dirty="0" smtClean="0"/>
              <a:t>1A </a:t>
            </a:r>
            <a:endParaRPr lang="en-US" sz="2400" dirty="0"/>
          </a:p>
        </p:txBody>
      </p:sp>
      <p:sp>
        <p:nvSpPr>
          <p:cNvPr id="24" name="Rectangle 23"/>
          <p:cNvSpPr/>
          <p:nvPr/>
        </p:nvSpPr>
        <p:spPr>
          <a:xfrm>
            <a:off x="152400" y="541996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834744" y="281940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25"/>
          <p:cNvPicPr/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75000"/>
                    </a14:imgEffect>
                    <a14:imgEffect>
                      <a14:saturation sat="400000"/>
                    </a14:imgEffect>
                    <a14:imgEffect>
                      <a14:brightnessContrast bright="17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94960" y="1295400"/>
            <a:ext cx="3672840" cy="24622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365406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55063" y="832366"/>
            <a:ext cx="646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GWT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07663" y="832366"/>
            <a:ext cx="592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GKO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450263" y="106281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C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88463" y="1060966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G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02863" y="106096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C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962400" y="1060966"/>
            <a:ext cx="359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G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81000" y="2051566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</a:rPr>
              <a:t>Atrogin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64857" y="1356368"/>
            <a:ext cx="5094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</a:rPr>
              <a:t>pAKT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88657" y="1661168"/>
            <a:ext cx="6431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GAPDH</a:t>
            </a:r>
          </a:p>
        </p:txBody>
      </p:sp>
      <p:pic>
        <p:nvPicPr>
          <p:cNvPr id="22" name="Picture 3" descr="E:\Lab 5-7-15\Western Aging 9-2015\10-17-15 photoshop\10-23-15 western images\pAKT photosho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3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066799" y="1447538"/>
            <a:ext cx="3505201" cy="2202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3" name="Picture 2" descr="E:\Lab 5-7-15\Western Aging 9-2015\10-7-15 photoshop images\10-12-2015Atrogin Pierce 1 500 7 16 15 7 17 15 crop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1" y="2057584"/>
            <a:ext cx="3505200" cy="35599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24" name="Picture 4" descr="E:\Lab 5-7-15\Western Aging 9-2015\10-7-15 photoshop images\Fas GAPDH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6000"/>
                    </a14:imgEffect>
                  </a14:imgLayer>
                </a14:imgProps>
              </a:ext>
            </a:extLst>
          </a:blip>
          <a:srcRect r="1869" b="-18063"/>
          <a:stretch>
            <a:fillRect/>
          </a:stretch>
        </p:blipFill>
        <p:spPr bwMode="auto">
          <a:xfrm>
            <a:off x="1066801" y="1750104"/>
            <a:ext cx="3505200" cy="1974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25" name="Rectangle 24"/>
          <p:cNvSpPr/>
          <p:nvPr/>
        </p:nvSpPr>
        <p:spPr>
          <a:xfrm>
            <a:off x="6019800" y="0"/>
            <a:ext cx="22098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 smtClean="0"/>
              <a:t>*</a:t>
            </a:r>
            <a:r>
              <a:rPr lang="en-US" altLang="zh-CN" dirty="0" smtClean="0"/>
              <a:t> p&lt;0.05 for age</a:t>
            </a:r>
          </a:p>
          <a:p>
            <a:r>
              <a:rPr lang="en-US" altLang="zh-CN" dirty="0" smtClean="0"/>
              <a:t>§ p&lt;0.05 genotype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04800" y="2432566"/>
            <a:ext cx="8448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/>
              <a:t>Tubulin</a:t>
            </a:r>
            <a:endParaRPr lang="en-US" sz="1200" dirty="0"/>
          </a:p>
        </p:txBody>
      </p:sp>
      <p:pic>
        <p:nvPicPr>
          <p:cNvPr id="28" name="Picture 3" descr="E:\Lab 5-7-15\Western Aging 9-2015\10-17-15 photoshop\Atrogin Tubulin Aging Cont vs Ghrel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066801" y="2514600"/>
            <a:ext cx="3505200" cy="228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5902836"/>
              </p:ext>
            </p:extLst>
          </p:nvPr>
        </p:nvGraphicFramePr>
        <p:xfrm>
          <a:off x="4800600" y="533400"/>
          <a:ext cx="35814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0" name="Title 9"/>
          <p:cNvSpPr txBox="1">
            <a:spLocks/>
          </p:cNvSpPr>
          <p:nvPr/>
        </p:nvSpPr>
        <p:spPr>
          <a:xfrm>
            <a:off x="0" y="0"/>
            <a:ext cx="3200400" cy="502324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 smtClean="0"/>
              <a:t>Supplemental figure </a:t>
            </a:r>
            <a:r>
              <a:rPr lang="en-US" sz="2400" dirty="0" smtClean="0"/>
              <a:t>1B </a:t>
            </a:r>
            <a:endParaRPr lang="en-US" sz="2400" dirty="0"/>
          </a:p>
        </p:txBody>
      </p:sp>
      <p:sp>
        <p:nvSpPr>
          <p:cNvPr id="26" name="Rectangle 25"/>
          <p:cNvSpPr/>
          <p:nvPr/>
        </p:nvSpPr>
        <p:spPr>
          <a:xfrm>
            <a:off x="211723" y="553998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4953000" y="184666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4758075" y="3098800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0353202"/>
              </p:ext>
            </p:extLst>
          </p:nvPr>
        </p:nvGraphicFramePr>
        <p:xfrm>
          <a:off x="4933950" y="3352800"/>
          <a:ext cx="3155571" cy="3100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368" b="10871"/>
          <a:stretch/>
        </p:blipFill>
        <p:spPr bwMode="auto">
          <a:xfrm>
            <a:off x="1256961" y="3474607"/>
            <a:ext cx="3519775" cy="2978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710373" y="3045245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1652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2971800" y="3243349"/>
            <a:ext cx="3202032" cy="2943195"/>
            <a:chOff x="208099" y="1308838"/>
            <a:chExt cx="4242159" cy="3310757"/>
          </a:xfrm>
        </p:grpSpPr>
        <p:pic>
          <p:nvPicPr>
            <p:cNvPr id="24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58" r="5525" b="7087"/>
            <a:stretch/>
          </p:blipFill>
          <p:spPr bwMode="auto">
            <a:xfrm>
              <a:off x="538843" y="1308838"/>
              <a:ext cx="3911415" cy="33107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Rectangle 27"/>
            <p:cNvSpPr/>
            <p:nvPr/>
          </p:nvSpPr>
          <p:spPr>
            <a:xfrm rot="16200000">
              <a:off x="-146928" y="2753888"/>
              <a:ext cx="1058835" cy="3487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228600" y="76200"/>
            <a:ext cx="26468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4225" y="409545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Rectangle 7"/>
          <p:cNvSpPr/>
          <p:nvPr/>
        </p:nvSpPr>
        <p:spPr>
          <a:xfrm>
            <a:off x="3072811" y="285557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9"/>
          <p:cNvGrpSpPr/>
          <p:nvPr/>
        </p:nvGrpSpPr>
        <p:grpSpPr>
          <a:xfrm>
            <a:off x="228600" y="617668"/>
            <a:ext cx="2743200" cy="2201732"/>
            <a:chOff x="358359" y="1066800"/>
            <a:chExt cx="4218402" cy="3250176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0" t="2072" r="5296" b="6227"/>
            <a:stretch/>
          </p:blipFill>
          <p:spPr bwMode="auto">
            <a:xfrm>
              <a:off x="635758" y="1066800"/>
              <a:ext cx="3941003" cy="32501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Rectangle 11"/>
            <p:cNvSpPr/>
            <p:nvPr/>
          </p:nvSpPr>
          <p:spPr>
            <a:xfrm rot="16200000">
              <a:off x="-77493" y="2422044"/>
              <a:ext cx="1224765" cy="353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1200" b="1" dirty="0" smtClean="0">
                  <a:latin typeface="Calibri"/>
                  <a:cs typeface="Arial" panose="020B0604020202020204" pitchFamily="34" charset="0"/>
                </a:rPr>
                <a:t>γ</a:t>
              </a:r>
              <a:r>
                <a:rPr lang="en-US" sz="1400" b="1" dirty="0" smtClean="0">
                  <a:latin typeface="Calibri"/>
                  <a:cs typeface="Calibri"/>
                </a:rPr>
                <a:t> pg/m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12"/>
          <p:cNvGrpSpPr/>
          <p:nvPr/>
        </p:nvGrpSpPr>
        <p:grpSpPr>
          <a:xfrm>
            <a:off x="3201857" y="386795"/>
            <a:ext cx="2741743" cy="2432605"/>
            <a:chOff x="4726479" y="1066800"/>
            <a:chExt cx="4188921" cy="3250176"/>
          </a:xfrm>
        </p:grpSpPr>
        <p:pic>
          <p:nvPicPr>
            <p:cNvPr id="14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3" r="6570" b="5077"/>
            <a:stretch/>
          </p:blipFill>
          <p:spPr bwMode="auto">
            <a:xfrm>
              <a:off x="5159829" y="1066800"/>
              <a:ext cx="3755571" cy="32501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" name="Rectangle 14"/>
            <p:cNvSpPr/>
            <p:nvPr/>
          </p:nvSpPr>
          <p:spPr>
            <a:xfrm rot="16200000">
              <a:off x="4246312" y="2533550"/>
              <a:ext cx="1307369" cy="34703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0 </a:t>
              </a:r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6019741" y="41687"/>
            <a:ext cx="3706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20"/>
          <p:cNvGrpSpPr/>
          <p:nvPr/>
        </p:nvGrpSpPr>
        <p:grpSpPr>
          <a:xfrm>
            <a:off x="6060073" y="386795"/>
            <a:ext cx="3055240" cy="2356405"/>
            <a:chOff x="304800" y="1183481"/>
            <a:chExt cx="4132997" cy="3244756"/>
          </a:xfrm>
        </p:grpSpPr>
        <p:pic>
          <p:nvPicPr>
            <p:cNvPr id="22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9" r="6181" b="7931"/>
            <a:stretch/>
          </p:blipFill>
          <p:spPr bwMode="auto">
            <a:xfrm>
              <a:off x="609600" y="1183481"/>
              <a:ext cx="3828197" cy="32447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Rectangle 22"/>
            <p:cNvSpPr/>
            <p:nvPr/>
          </p:nvSpPr>
          <p:spPr>
            <a:xfrm rot="16200000">
              <a:off x="-238778" y="2603350"/>
              <a:ext cx="13949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2p70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</a:p>
          </p:txBody>
        </p:sp>
      </p:grpSp>
      <p:grpSp>
        <p:nvGrpSpPr>
          <p:cNvPr id="6" name="Group 23"/>
          <p:cNvGrpSpPr/>
          <p:nvPr/>
        </p:nvGrpSpPr>
        <p:grpSpPr>
          <a:xfrm>
            <a:off x="148549" y="3395298"/>
            <a:ext cx="2806979" cy="2776902"/>
            <a:chOff x="4773626" y="1223962"/>
            <a:chExt cx="4274319" cy="3438360"/>
          </a:xfrm>
        </p:grpSpPr>
        <p:pic>
          <p:nvPicPr>
            <p:cNvPr id="25" name="Picture 3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28" r="6465" b="5904"/>
            <a:stretch/>
          </p:blipFill>
          <p:spPr bwMode="auto">
            <a:xfrm>
              <a:off x="5199281" y="1223962"/>
              <a:ext cx="3848664" cy="3438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 rot="16200000">
              <a:off x="4085793" y="2228425"/>
              <a:ext cx="1801321" cy="4256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l-G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Rectangle 26"/>
          <p:cNvSpPr/>
          <p:nvPr/>
        </p:nvSpPr>
        <p:spPr>
          <a:xfrm>
            <a:off x="62262" y="3186278"/>
            <a:ext cx="33660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3033556" y="2931618"/>
            <a:ext cx="33660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162017" y="2906378"/>
            <a:ext cx="9596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6087153" y="3436039"/>
            <a:ext cx="2963776" cy="2751921"/>
            <a:chOff x="4644935" y="1524000"/>
            <a:chExt cx="4194265" cy="3095596"/>
          </a:xfrm>
        </p:grpSpPr>
        <p:pic>
          <p:nvPicPr>
            <p:cNvPr id="32" name="Picture 31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92" t="2866" r="6660" b="7726"/>
            <a:stretch/>
          </p:blipFill>
          <p:spPr bwMode="auto">
            <a:xfrm>
              <a:off x="5110843" y="1524000"/>
              <a:ext cx="3728357" cy="30955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3" name="TextBox 32"/>
            <p:cNvSpPr txBox="1"/>
            <p:nvPr/>
          </p:nvSpPr>
          <p:spPr>
            <a:xfrm rot="16200000">
              <a:off x="4114058" y="2664477"/>
              <a:ext cx="1449289" cy="387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1083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4</TotalTime>
  <Words>84</Words>
  <Application>Microsoft Office PowerPoint</Application>
  <PresentationFormat>On-screen Show (4:3)</PresentationFormat>
  <Paragraphs>52</Paragraphs>
  <Slides>3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SPW 11.0 Graph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cia, Jose Manuel</dc:creator>
  <cp:lastModifiedBy>Garcia, Jose Manuel</cp:lastModifiedBy>
  <cp:revision>9</cp:revision>
  <dcterms:created xsi:type="dcterms:W3CDTF">2016-11-03T00:08:17Z</dcterms:created>
  <dcterms:modified xsi:type="dcterms:W3CDTF">2017-02-17T00:32:56Z</dcterms:modified>
</cp:coreProperties>
</file>